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480175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2790" y="114"/>
      </p:cViewPr>
      <p:guideLst>
        <p:guide orient="horz" pos="2495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8075842606567134"/>
          <c:y val="7.6520200812383102E-2"/>
          <c:w val="0.61271023264842872"/>
          <c:h val="0.607077557453680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46A1-4BD7-ADED-8B31DA909BDF}"/>
                </c:ex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-1.3572798960364227E-16"/>
                  <c:y val="-2.2990198528991194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46A1-4BD7-ADED-8B31DA909BDF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noFill/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1!$C$1:$C$2</c:f>
                <c:numCache>
                  <c:formatCode>General</c:formatCode>
                  <c:ptCount val="2"/>
                  <c:pt idx="0">
                    <c:v>0.12003999999999999</c:v>
                  </c:pt>
                  <c:pt idx="1">
                    <c:v>0.12444</c:v>
                  </c:pt>
                </c:numCache>
              </c:numRef>
            </c:plus>
            <c:minus>
              <c:numRef>
                <c:f>Sheet1!$C$1:$C$2</c:f>
                <c:numCache>
                  <c:formatCode>General</c:formatCode>
                  <c:ptCount val="2"/>
                  <c:pt idx="0">
                    <c:v>0.12003999999999999</c:v>
                  </c:pt>
                  <c:pt idx="1">
                    <c:v>0.124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:$A$2</c:f>
              <c:strCache>
                <c:ptCount val="2"/>
                <c:pt idx="0">
                  <c:v>GFP</c:v>
                </c:pt>
                <c:pt idx="1">
                  <c:v>VvAPX1-GFP</c:v>
                </c:pt>
              </c:strCache>
            </c:strRef>
          </c:cat>
          <c:val>
            <c:numRef>
              <c:f>Sheet1!$B$1:$B$2</c:f>
              <c:numCache>
                <c:formatCode>General</c:formatCode>
                <c:ptCount val="2"/>
                <c:pt idx="0">
                  <c:v>1</c:v>
                </c:pt>
                <c:pt idx="1">
                  <c:v>1.382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6A1-4BD7-ADED-8B31DA909BD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223901216"/>
        <c:axId val="223903960"/>
      </c:barChart>
      <c:catAx>
        <c:axId val="223901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3903960"/>
        <c:crosses val="autoZero"/>
        <c:auto val="1"/>
        <c:lblAlgn val="ctr"/>
        <c:lblOffset val="100"/>
        <c:noMultiLvlLbl val="0"/>
      </c:catAx>
      <c:valAx>
        <c:axId val="223903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aseline="0" dirty="0">
                    <a:solidFill>
                      <a:schemeClr val="tx1"/>
                    </a:solidFill>
                  </a:rPr>
                  <a:t>Expression level of </a:t>
                </a:r>
                <a:r>
                  <a:rPr lang="en-US" i="1" baseline="0" dirty="0">
                    <a:solidFill>
                      <a:schemeClr val="tx1"/>
                    </a:solidFill>
                  </a:rPr>
                  <a:t>VvAPX</a:t>
                </a:r>
                <a:r>
                  <a:rPr lang="en-US" altLang="zh-CN" i="1" baseline="0" dirty="0">
                    <a:solidFill>
                      <a:schemeClr val="tx1"/>
                    </a:solidFill>
                  </a:rPr>
                  <a:t>1</a:t>
                </a:r>
                <a:endParaRPr lang="zh-CN" i="1" baseline="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3.7490672177257336E-2"/>
              <c:y val="3.31335378986043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3901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7096373452079945"/>
          <c:y val="3.97462391256556E-2"/>
          <c:w val="0.62903626547920055"/>
          <c:h val="0.6401638526879895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8DA5-47FA-8AD4-905CB23A60F4}"/>
                </c:ex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0"/>
                  <c:y val="-1.3176756254012748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8DA5-47FA-8AD4-905CB23A60F4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2!$C$1:$C$2</c:f>
                <c:numCache>
                  <c:formatCode>General</c:formatCode>
                  <c:ptCount val="2"/>
                  <c:pt idx="0">
                    <c:v>0.25274999999999997</c:v>
                  </c:pt>
                  <c:pt idx="1">
                    <c:v>3.6213600000000001</c:v>
                  </c:pt>
                </c:numCache>
              </c:numRef>
            </c:plus>
            <c:minus>
              <c:numRef>
                <c:f>Sheet2!$C$1:$C$2</c:f>
                <c:numCache>
                  <c:formatCode>General</c:formatCode>
                  <c:ptCount val="2"/>
                  <c:pt idx="0">
                    <c:v>0.25274999999999997</c:v>
                  </c:pt>
                  <c:pt idx="1">
                    <c:v>3.62136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1:$A$2</c:f>
              <c:strCache>
                <c:ptCount val="2"/>
                <c:pt idx="0">
                  <c:v>GFP</c:v>
                </c:pt>
                <c:pt idx="1">
                  <c:v>VvBKI1-GFP</c:v>
                </c:pt>
              </c:strCache>
            </c:strRef>
          </c:cat>
          <c:val>
            <c:numRef>
              <c:f>Sheet2!$B$1:$B$2</c:f>
              <c:numCache>
                <c:formatCode>General</c:formatCode>
                <c:ptCount val="2"/>
                <c:pt idx="0">
                  <c:v>1</c:v>
                </c:pt>
                <c:pt idx="1">
                  <c:v>29.61555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DA5-47FA-8AD4-905CB23A60F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223902000"/>
        <c:axId val="223903568"/>
      </c:barChart>
      <c:catAx>
        <c:axId val="223902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3903568"/>
        <c:crosses val="autoZero"/>
        <c:auto val="1"/>
        <c:lblAlgn val="ctr"/>
        <c:lblOffset val="100"/>
        <c:noMultiLvlLbl val="0"/>
      </c:catAx>
      <c:valAx>
        <c:axId val="2239035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Expression level  of </a:t>
                </a:r>
                <a:r>
                  <a:rPr lang="en-US" i="1" dirty="0"/>
                  <a:t>VvBKI1</a:t>
                </a:r>
                <a:endParaRPr lang="zh-CN" i="1" dirty="0"/>
              </a:p>
            </c:rich>
          </c:tx>
          <c:layout>
            <c:manualLayout>
              <c:xMode val="edge"/>
              <c:yMode val="edge"/>
              <c:x val="4.5079373238961488E-2"/>
              <c:y val="5.90160636589018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39020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296173"/>
            <a:ext cx="5508149" cy="275734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159854"/>
            <a:ext cx="4860131" cy="1912175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9191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6607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21669"/>
            <a:ext cx="1397288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21669"/>
            <a:ext cx="4110861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7951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0958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974512"/>
            <a:ext cx="5589151" cy="3294515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300194"/>
            <a:ext cx="5589151" cy="173250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8059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108344"/>
            <a:ext cx="2754074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108344"/>
            <a:ext cx="2754074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2252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21671"/>
            <a:ext cx="5589151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941510"/>
            <a:ext cx="2741417" cy="95150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893014"/>
            <a:ext cx="2741417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941510"/>
            <a:ext cx="2754918" cy="95150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893014"/>
            <a:ext cx="2754918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6455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7739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1423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8002"/>
            <a:ext cx="2090025" cy="1848009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140341"/>
            <a:ext cx="3280589" cy="5628360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76011"/>
            <a:ext cx="2090025" cy="440185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209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8002"/>
            <a:ext cx="2090025" cy="1848009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140341"/>
            <a:ext cx="3280589" cy="5628360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76011"/>
            <a:ext cx="2090025" cy="440185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2481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21671"/>
            <a:ext cx="5589151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108344"/>
            <a:ext cx="5589151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7340703"/>
            <a:ext cx="145803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3C0FD-CDCA-40B9-9076-26512B3A020D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7340703"/>
            <a:ext cx="218705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7340703"/>
            <a:ext cx="145803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5B9ACB-F143-404C-BD63-15AE4015E9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649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xmlns="" id="{83BC42F0-7927-4737-4576-2C18DF09BB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6410339"/>
              </p:ext>
            </p:extLst>
          </p:nvPr>
        </p:nvGraphicFramePr>
        <p:xfrm>
          <a:off x="3578672" y="839569"/>
          <a:ext cx="1813066" cy="2168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9794181A-7173-03C7-0F9C-3F6BE86DD15A}"/>
              </a:ext>
            </a:extLst>
          </p:cNvPr>
          <p:cNvSpPr txBox="1"/>
          <p:nvPr/>
        </p:nvSpPr>
        <p:spPr>
          <a:xfrm>
            <a:off x="0" y="3156860"/>
            <a:ext cx="641497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altLang="zh-CN" sz="1200" b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1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 Expression level of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vBKI1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vAPX1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grape leaves after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groinfiltration.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Transcript level of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vBKI1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grape, four days after agroinfiltration. (B) Transcript level of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vAPX1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grape, four days after agroinfiltration. * represents significant difference (p&lt;0.05, Student’s t test),  ** represents extremely significant difference (p&lt;0.01, Student’s t test).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en-US" sz="1200" dirty="0"/>
          </a:p>
        </p:txBody>
      </p:sp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xmlns="" id="{B6F32071-82ED-371C-BD38-D440D922EE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5581912"/>
              </p:ext>
            </p:extLst>
          </p:nvPr>
        </p:nvGraphicFramePr>
        <p:xfrm>
          <a:off x="833549" y="840389"/>
          <a:ext cx="1867506" cy="23164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F5EF855A-1B20-933A-20F6-CB2A428EEA77}"/>
              </a:ext>
            </a:extLst>
          </p:cNvPr>
          <p:cNvSpPr txBox="1"/>
          <p:nvPr/>
        </p:nvSpPr>
        <p:spPr>
          <a:xfrm>
            <a:off x="705736" y="489440"/>
            <a:ext cx="50545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2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71E55784-21E4-646A-2446-008D84527A30}"/>
              </a:ext>
            </a:extLst>
          </p:cNvPr>
          <p:cNvSpPr txBox="1"/>
          <p:nvPr/>
        </p:nvSpPr>
        <p:spPr>
          <a:xfrm>
            <a:off x="3170718" y="489439"/>
            <a:ext cx="50545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546637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等线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等线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2</TotalTime>
  <Words>85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79984</dc:creator>
  <cp:lastModifiedBy>MDPI</cp:lastModifiedBy>
  <cp:revision>12</cp:revision>
  <dcterms:created xsi:type="dcterms:W3CDTF">2022-11-10T03:57:29Z</dcterms:created>
  <dcterms:modified xsi:type="dcterms:W3CDTF">2023-03-07T10:58:18Z</dcterms:modified>
</cp:coreProperties>
</file>